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6" d="100"/>
          <a:sy n="96" d="100"/>
        </p:scale>
        <p:origin x="101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814854-2366-42DC-919E-5398AF4296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223AF4-D0B5-4B06-B1B3-B6CDD3CE96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C13E0F-72A6-4836-9FB6-2CCE71DC57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B93265-0CA2-489F-B26C-30554C1F9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E031FE-F034-404C-98F7-53B1F91E1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69272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D6DD85-7225-4129-A0EA-ABA537AFA1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5742D90-7F90-41AF-9955-7A447CF952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CBB780-D715-4560-9627-D3916E84D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42C4DD2-13C1-48F7-8649-D5C896FBD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EE91BE3-4F20-4EA3-9292-E5F700A07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89843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3A359DA-3821-472C-B808-E26F0C9600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0BC5386-2201-4D23-B99A-895FAA1369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B63896-02C1-471B-84F1-31D084251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81D391-8AE8-4783-A8EC-0FDADAFF4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E1AD23-5C77-4CD0-90DA-DB71EFE003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155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35EBF0-33F4-4E3D-B65B-21CAFF1FCA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7966FC-FD61-451D-8192-BA34CBD94C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8A9433-6059-42B6-A1AA-7AF49466E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5212271-6B32-47DF-9DB6-CE212152F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58B159-B0F9-45F9-AABB-03E489A0A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2641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534D14-1529-4444-A80D-FE016B6F27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F7AE081-8C41-4BB2-A798-EC0FC943DE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817311-81CD-49E6-8240-29A3341AC1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446764C-7B56-4967-9EB0-5AFCC41705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AE704C-EA7C-4D40-B17A-B43F717FD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8055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FDA63A-35D6-4DD9-AFE7-3FA3203582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0EE4AE5-EDAA-4933-B31C-9A288F278D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1AAB566-7F61-4A6A-96AC-B241034C75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36AA141-FC99-4EA5-9ACF-B58984A48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05728C0-ABD3-4D94-B883-1EA1AD484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4C196A1-6207-453F-83F3-511005191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7059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C9C572-9AA9-4524-8516-FD974A2107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4916BD6-7E8B-40B8-80C8-397F4BDFC7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8E92ECB-6BCB-4CFC-A330-3BA1001C2E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CD6CF56-A11C-44E7-842D-DF50661A63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E2CBAC0-80C1-4C8F-B3CA-DA33870DC4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61D00BB-04F6-45AA-821B-E5BFB61A1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65DCB0D-5AC7-4CD2-BC60-F286C3D60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C3A3EB3-59F3-4082-B038-A93C9CBDA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7115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15D701-5C7A-4C6F-8F69-99E1E6BEAF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43AB703-B586-46E3-A790-D97B400CB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9887F5F-436F-4CC6-B856-535CD899E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3B1E434-A5BF-4FBA-8224-1218D3295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08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7DA7A90-EA32-46B6-94D9-22A5AF5DF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565CF67-E95F-466A-830C-8FDEBF6D4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4814E32-EDE5-474F-9ED5-950392FC2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6713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D1F648-EB8A-4E25-A571-BC539C8F3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839E0C0-7D2A-4A5C-8700-0E1F3D12CE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95956C8-DC56-4727-A7EA-5E70463E2B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19F76A0-51CD-47E2-8B85-FB20A67AA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E89DE49-6901-43FC-B801-A4A217BD6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A615B1A-E94A-43F4-AFF2-EE6245B41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2304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D1BB2A-CD43-4742-9D71-FA62BA3FD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FD806BB-0AAE-4032-8530-4E31516207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6F8DE99-9E0F-4492-B23B-23EFD9D3B6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04C05EE-40C4-479A-98C9-DFB38DF5A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D6F9542-8116-4DEB-964C-8A93F456F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D9141C4-C488-4998-8350-6DDE9F5F4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1417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1DE41ED-680D-4531-88EF-B0693126BB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B21DB1F-AE5E-47B4-B9FE-58D56987B4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D346E6-3A47-4C4E-BDFC-6723CFD340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C40DB9-29F5-4560-A2C3-88CDDCB926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0BE74E0-0162-42C4-B72F-B4ADDFB7EF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181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BB245BE3-3F03-4AB0-9F65-C8126D8071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8825" y="1028700"/>
            <a:ext cx="8134350" cy="4800600"/>
          </a:xfrm>
          <a:prstGeom prst="rect">
            <a:avLst/>
          </a:prstGeom>
        </p:spPr>
      </p:pic>
      <p:sp>
        <p:nvSpPr>
          <p:cNvPr id="3" name="Rectangle 97">
            <a:extLst>
              <a:ext uri="{FF2B5EF4-FFF2-40B4-BE49-F238E27FC236}">
                <a16:creationId xmlns:a16="http://schemas.microsoft.com/office/drawing/2014/main" id="{8945C69C-64C1-4571-8DFE-1E154C697E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6901" y="2828636"/>
            <a:ext cx="104939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en-US" altLang="ja-JP" sz="1800" b="1" dirty="0">
                <a:solidFill>
                  <a:srgbClr val="000000"/>
                </a:solidFill>
                <a:latin typeface="Arial" panose="020B0604020202020204" pitchFamily="34" charset="0"/>
                <a:ea typeface="MS UI Gothic"/>
                <a:cs typeface="Arial" panose="020B0604020202020204" pitchFamily="34" charset="0"/>
              </a:rPr>
              <a:t> </a:t>
            </a:r>
            <a:r>
              <a:rPr lang="en-US" altLang="ja-JP" sz="1800" b="1" i="1">
                <a:solidFill>
                  <a:srgbClr val="000000"/>
                </a:solidFill>
                <a:latin typeface="Arial" panose="020B0604020202020204" pitchFamily="34" charset="0"/>
                <a:ea typeface="MS UI Gothic"/>
                <a:cs typeface="Arial" panose="020B0604020202020204" pitchFamily="34" charset="0"/>
              </a:rPr>
              <a:t>P </a:t>
            </a:r>
            <a:r>
              <a:rPr lang="en-US" altLang="ja-JP" sz="1800" b="1">
                <a:solidFill>
                  <a:srgbClr val="000000"/>
                </a:solidFill>
                <a:latin typeface="Arial" panose="020B0604020202020204" pitchFamily="34" charset="0"/>
                <a:ea typeface="MS UI Gothic"/>
                <a:cs typeface="Arial" panose="020B0604020202020204" pitchFamily="34" charset="0"/>
              </a:rPr>
              <a:t>= 0.002</a:t>
            </a:r>
            <a:endParaRPr lang="ja-JP" altLang="en-US" sz="1800" b="1" u="none" strike="noStrike" baseline="0" dirty="0">
              <a:solidFill>
                <a:srgbClr val="000000"/>
              </a:solidFill>
              <a:latin typeface="Arial" panose="020B0604020202020204" pitchFamily="34" charset="0"/>
              <a:ea typeface="MS UI Gothic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8C82BE5-79D5-47F4-A446-894D67F1B69C}"/>
              </a:ext>
            </a:extLst>
          </p:cNvPr>
          <p:cNvSpPr txBox="1"/>
          <p:nvPr/>
        </p:nvSpPr>
        <p:spPr>
          <a:xfrm>
            <a:off x="1371602" y="5393487"/>
            <a:ext cx="18478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4AB9A9C-0548-4A5C-9CDC-9503936D6573}"/>
              </a:ext>
            </a:extLst>
          </p:cNvPr>
          <p:cNvSpPr txBox="1"/>
          <p:nvPr/>
        </p:nvSpPr>
        <p:spPr>
          <a:xfrm>
            <a:off x="1371602" y="5810338"/>
            <a:ext cx="76513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GPS:0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r 1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9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54         47         40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16        13    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767738C-A911-4004-8624-74A9DD6D3B81}"/>
              </a:ext>
            </a:extLst>
          </p:cNvPr>
          <p:cNvSpPr txBox="1"/>
          <p:nvPr/>
        </p:nvSpPr>
        <p:spPr>
          <a:xfrm>
            <a:off x="1725708" y="6203591"/>
            <a:ext cx="76513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GPS: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35         26         15         12          6           5           4           2          1   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D490AABB-C639-42A3-8795-E2F0F744FF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52258" y="2161836"/>
            <a:ext cx="573074" cy="377985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3D94C5B-8803-43BA-BEF7-F7D78643547A}"/>
              </a:ext>
            </a:extLst>
          </p:cNvPr>
          <p:cNvSpPr txBox="1"/>
          <p:nvPr/>
        </p:nvSpPr>
        <p:spPr>
          <a:xfrm>
            <a:off x="0" y="0"/>
            <a:ext cx="12192000" cy="1115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1.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Overall survival in patients with unresectable or metastatic biliary tract cancer receiving gemcitabine plus cisplatin based on the modified Glasgow Prognostic Score (</a:t>
            </a:r>
            <a:r>
              <a:rPr lang="en-US" altLang="ja-JP" sz="18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GPS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; 0–1 vs. 2).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9788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67</Words>
  <Application>Microsoft Office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司弥生</dc:creator>
  <cp:lastModifiedBy>KAZUMA FUJITA</cp:lastModifiedBy>
  <cp:revision>17</cp:revision>
  <dcterms:created xsi:type="dcterms:W3CDTF">2024-07-04T09:22:40Z</dcterms:created>
  <dcterms:modified xsi:type="dcterms:W3CDTF">2025-12-05T04:34:24Z</dcterms:modified>
</cp:coreProperties>
</file>